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5" d="100"/>
          <a:sy n="85" d="100"/>
        </p:scale>
        <p:origin x="590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F4D1F2-E012-415F-A4F1-720466C5B4E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3D155B7-68E7-4E18-A0BA-71157DAEE0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BBB6D2-E66E-4B9B-9575-5DCE41DAA6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FE1120-0657-4B7C-84F1-FA92E34E2F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410A30-2E09-4FAE-AD5B-9E75A96C23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05310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F3A87B-6D7C-4337-A96E-43FD777DB0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35586A-D7B0-4CB2-96C6-83047C5EA5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086DC9-57F6-4F1F-8FEE-C7101D7F0B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83BBBC-B313-4B5B-BC83-0BD0DA6AAA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B31B73-4513-4812-A017-5BECCD2186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427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04F4D08-F886-446B-863D-368EE2D6426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2A87B75-09E4-4A07-BC36-10EF3D1314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09DAEF-9F52-4F52-9B44-9005670F22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59DE1D-CF31-45D0-8313-B368319555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062AB7-E429-4E9E-A3C5-F7D4A85952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257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6B2B03-EC8E-467A-868D-7A568448E1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54A76E-3B92-4D10-ABBF-6FBF5265115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BEC2B0-D9BD-4469-86EC-71B1B96633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92D4F7-B754-45D6-A035-F1CD2BE637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923FE1-1443-4A9E-B510-F47ADC28C6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0376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600B09-1B36-4EB8-865D-D58B350971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A3E53E-56AD-419A-B1B6-D8A59144FD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ACB315-BF37-4041-84A0-74A69F8CEA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F2EE01-9533-4653-9811-B7B7EC9C58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7B0D7F-08B7-4D35-ACC6-CAEB77EA95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009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959F46-6406-471C-AD31-AE6DDC8666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AEC87D-0F70-46E0-971D-463B81D683D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DDD2C0-24C5-4157-A9E2-8846E11BF2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692116-39CA-4D5D-863A-4B3283759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7A34A0-3C23-4CDD-90F6-68D5116FAC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390FE2-CB6A-44F5-9A7C-82023D0B04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378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543F14-BF84-4CBE-83B8-9F16C9D713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FFB9E7-DF82-4E87-A69D-797B580D82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6C99CF7-2508-468F-8845-B7B9858865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9D842DF-EE9F-4A85-9CD0-119552599A0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8834342-BF04-46EE-B6BB-0A815F974ED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9FD9227-9D3C-44B7-ABBC-F1B1E6B719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84FD7BB-F7B8-4621-9724-954171F6CD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DAB32F3-5DFB-45F6-A2D6-60816ABDBF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01274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53FC20-98B7-4DD7-8871-C1A0E2EF04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E8F51F9-95F9-4FD5-841C-9AC3B0303E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3803A18-47AA-41FB-BA34-FFECDCA4CC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804D5DB-24F1-467A-94C2-34A7EA70F7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8834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6F7FDC5-9221-4868-AEB7-6CD98EE65D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2888F57-35EA-46C9-B895-19579B3C82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534B09F-B9CA-4978-A841-C462A6CE5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3465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D0A954-E5B8-415B-8FA7-031B6D8045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B48332-CC18-4C25-8B63-3F6BA739AC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0450835-E89B-4420-AFB4-4852F15FC7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D0B98A-D3EE-4993-9DD0-5B72CAB9EE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09DCD8-661F-42A0-9A7D-F3087250E1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17060D-E7DA-440D-98FF-D5D8CF58A1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7739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09E6B9-ED30-443B-942F-0589B6E505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E0C90E6-0BBD-4159-A1C5-2990C3B5E10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22BAF86-1B0D-4A6C-B3A8-6C55F1E1E4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19A152-5B55-491F-B5E7-9EE7F07F6D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B3DEB8-22D8-4101-8537-D1BBA8584F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CE7D22-2F40-45E6-98B6-EFA0E86D66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0032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CE904AA-049D-49A4-9C82-FB5060A085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C05164-1C5B-47ED-AB5A-8E635D270F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D9597A-BF87-4A90-8D83-842A94A23B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9C7D36-2CB4-4B97-AEC7-99F434723B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8B6924-39D2-48AE-B542-906637B6E9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2318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A graph of numbers and colors&#10;&#10;Description automatically generated with medium confidence">
            <a:extLst>
              <a:ext uri="{FF2B5EF4-FFF2-40B4-BE49-F238E27FC236}">
                <a16:creationId xmlns:a16="http://schemas.microsoft.com/office/drawing/2014/main" id="{34AA0FAC-A89B-4D45-98F1-A5DBDE05AE1D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013010" y="1315742"/>
            <a:ext cx="5450541" cy="3783105"/>
          </a:xfrm>
          <a:prstGeom prst="rect">
            <a:avLst/>
          </a:prstGeom>
        </p:spPr>
      </p:pic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482787C1-1EEE-45B9-AA95-74756827AC4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5523802"/>
              </p:ext>
            </p:extLst>
          </p:nvPr>
        </p:nvGraphicFramePr>
        <p:xfrm>
          <a:off x="6777317" y="1954307"/>
          <a:ext cx="3863788" cy="2729589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10116">
                  <a:extLst>
                    <a:ext uri="{9D8B030D-6E8A-4147-A177-3AD203B41FA5}">
                      <a16:colId xmlns:a16="http://schemas.microsoft.com/office/drawing/2014/main" val="2051060843"/>
                    </a:ext>
                  </a:extLst>
                </a:gridCol>
                <a:gridCol w="3253672">
                  <a:extLst>
                    <a:ext uri="{9D8B030D-6E8A-4147-A177-3AD203B41FA5}">
                      <a16:colId xmlns:a16="http://schemas.microsoft.com/office/drawing/2014/main" val="1514105452"/>
                    </a:ext>
                  </a:extLst>
                </a:gridCol>
              </a:tblGrid>
              <a:tr h="233187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K59.00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Constipation, unspecified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617110680"/>
                  </a:ext>
                </a:extLst>
              </a:tr>
              <a:tr h="233187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K59.03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Drug induced constipation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57993238"/>
                  </a:ext>
                </a:extLst>
              </a:tr>
              <a:tr h="233187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K59.09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other and unspecified constipation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59551188"/>
                  </a:ext>
                </a:extLst>
              </a:tr>
              <a:tr h="233187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K29.70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Gastritis, unspecified, without bleeding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05020980"/>
                  </a:ext>
                </a:extLst>
              </a:tr>
              <a:tr h="241628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K21.9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gastroesophageal reflux disease (GERD) without esophagitis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39814313"/>
                  </a:ext>
                </a:extLst>
              </a:tr>
              <a:tr h="233187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K29.60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Other gastritis without bleeding.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31196183"/>
                  </a:ext>
                </a:extLst>
              </a:tr>
              <a:tr h="233187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564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Constipation, unspecified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97315287"/>
                  </a:ext>
                </a:extLst>
              </a:tr>
              <a:tr h="233187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K12.30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Oral mucositis (ulcerative)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7426224"/>
                  </a:ext>
                </a:extLst>
              </a:tr>
              <a:tr h="233187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K52.9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Noninfective gastroenteritis and colitis, unspecified.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18376331"/>
                  </a:ext>
                </a:extLst>
              </a:tr>
              <a:tr h="233187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530.81</a:t>
                      </a:r>
                      <a:endParaRPr lang="en-US" sz="12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Gastro-esophageal reflux disease without esophagitis.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34230218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4DB35EB3-6A46-4E99-A156-0E154EB2E479}"/>
              </a:ext>
            </a:extLst>
          </p:cNvPr>
          <p:cNvSpPr txBox="1"/>
          <p:nvPr/>
        </p:nvSpPr>
        <p:spPr>
          <a:xfrm>
            <a:off x="842682" y="663388"/>
            <a:ext cx="26625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S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243ED8A-ABA2-443D-85A3-50ADD4450CDF}"/>
              </a:ext>
            </a:extLst>
          </p:cNvPr>
          <p:cNvSpPr txBox="1"/>
          <p:nvPr/>
        </p:nvSpPr>
        <p:spPr>
          <a:xfrm>
            <a:off x="1846729" y="5594447"/>
            <a:ext cx="815788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kern="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Top 10 common diagnosis in digestive tract disorders (with each diagnosis code counted once per patient within the 3 months prior to their ALL/LL diagnosis, regardless of multiple occurrences)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554384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97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nest Amankwah</dc:creator>
  <cp:lastModifiedBy>Ernest Amankwah</cp:lastModifiedBy>
  <cp:revision>3</cp:revision>
  <dcterms:created xsi:type="dcterms:W3CDTF">2025-01-04T14:01:47Z</dcterms:created>
  <dcterms:modified xsi:type="dcterms:W3CDTF">2025-01-04T14:25:07Z</dcterms:modified>
</cp:coreProperties>
</file>